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86400" cy="36576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46212-3AA2-4BED-A66E-EC6C0F0234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4680" y="853560"/>
            <a:ext cx="493704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4680" y="2114280"/>
            <a:ext cx="493704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2A1146-07E9-4A63-A9FE-D381275A26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4680" y="85356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804760" y="85356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4680" y="211428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804760" y="211428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CC078-AF8D-450D-BAE9-1CFBA78CB6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4680" y="853560"/>
            <a:ext cx="158940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44000" y="853560"/>
            <a:ext cx="158940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613320" y="853560"/>
            <a:ext cx="158940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4680" y="2114280"/>
            <a:ext cx="158940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44000" y="2114280"/>
            <a:ext cx="158940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613320" y="2114280"/>
            <a:ext cx="158940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FB21C7-A080-4E36-8D04-0DD5952D7F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4680" y="853560"/>
            <a:ext cx="493704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60082-EF99-4208-845F-0D25E12F1A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4680" y="853560"/>
            <a:ext cx="4937040" cy="24130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C2092C-2DAF-44E8-8663-CA5CB6602B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4680" y="853560"/>
            <a:ext cx="2409120" cy="24130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804760" y="853560"/>
            <a:ext cx="2409120" cy="24130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9D7C1-1827-4756-B586-1D61422EE8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2CACC-BF1E-42E1-A96C-1D49CD6278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4680" y="145800"/>
            <a:ext cx="493704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586E75-E5FD-448C-9A8B-B2C09E366B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4680" y="85356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804760" y="853560"/>
            <a:ext cx="2409120" cy="24130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4680" y="211428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A1375-3868-4D53-8127-09FECC451A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4680" y="853560"/>
            <a:ext cx="2409120" cy="24130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804760" y="85356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804760" y="211428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D7F79-49C0-4A72-8074-8D75A519E8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4680" y="85356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804760" y="853560"/>
            <a:ext cx="240912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4680" y="2114280"/>
            <a:ext cx="4937040" cy="11509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2E068-AD57-4634-BEE9-EB6511EE80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4680" y="145800"/>
            <a:ext cx="49370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4680" y="853560"/>
            <a:ext cx="4937040" cy="24130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marL="195120" indent="-19512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23720" indent="-16164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652320" indent="-12996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3" marL="914400" indent="-1303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4" marL="1176480" indent="-1317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5" marL="1176480" indent="-1317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6" marL="1176480" indent="-1317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74680" y="3330360"/>
            <a:ext cx="1279440" cy="25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Autofit/>
          </a:bodyPr>
          <a:lstStyle>
            <a:lvl1pPr indent="0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874880" y="3330360"/>
            <a:ext cx="1736640" cy="25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Autofit/>
          </a:bodyPr>
          <a:lstStyle>
            <a:lvl1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932280" y="3330360"/>
            <a:ext cx="1279440" cy="25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Autofit/>
          </a:bodyPr>
          <a:lstStyle>
            <a:lvl1pPr indent="0" algn="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fld id="{1A5D0734-FFA8-4DAE-9699-DA03020DB3CD}" type="slidenum">
              <a:rPr b="0" lang="en-US" sz="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8160" y="681120"/>
            <a:ext cx="5340240" cy="2783520"/>
            <a:chOff x="38160" y="681120"/>
            <a:chExt cx="5340240" cy="2783520"/>
          </a:xfrm>
        </p:grpSpPr>
        <p:grpSp>
          <p:nvGrpSpPr>
            <p:cNvPr id="42" name=""/>
            <p:cNvGrpSpPr/>
            <p:nvPr/>
          </p:nvGrpSpPr>
          <p:grpSpPr>
            <a:xfrm>
              <a:off x="38160" y="681120"/>
              <a:ext cx="5340240" cy="2783520"/>
              <a:chOff x="38160" y="681120"/>
              <a:chExt cx="5340240" cy="2783520"/>
            </a:xfrm>
          </p:grpSpPr>
          <p:graphicFrame>
            <p:nvGraphicFramePr>
              <p:cNvPr id="43" name=""/>
              <p:cNvGraphicFramePr/>
              <p:nvPr/>
            </p:nvGraphicFramePr>
            <p:xfrm>
              <a:off x="701640" y="698760"/>
              <a:ext cx="4676760" cy="2590560"/>
            </p:xfrm>
            <a:graphic>
              <a:graphicData uri="http://schemas.openxmlformats.org/presentationml/2006/ole">
                <p:oleObj progId="Excel.Sheet.12" r:id="rId1" spid="">
                  <p:embed/>
                  <p:pic>
                    <p:nvPicPr>
                      <p:cNvPr id="44" name="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701640" y="698760"/>
                        <a:ext cx="4676760" cy="25905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5" name=""/>
              <p:cNvSpPr/>
              <p:nvPr/>
            </p:nvSpPr>
            <p:spPr>
              <a:xfrm>
                <a:off x="1102320" y="3157560"/>
                <a:ext cx="8132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2818080" y="3157560"/>
                <a:ext cx="575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RG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4243680" y="3138480"/>
                <a:ext cx="566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RG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372240" y="135432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372240" y="101124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70880" y="167184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70880" y="200844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470880" y="233208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70880" y="265608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569880" y="29862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372240" y="68112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4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rot="16200000">
                <a:off x="-690840" y="1668960"/>
                <a:ext cx="1887480" cy="428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% Cell viability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(over non-treated cells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7" name=""/>
              <p:cNvGrpSpPr/>
              <p:nvPr/>
            </p:nvGrpSpPr>
            <p:grpSpPr>
              <a:xfrm>
                <a:off x="977760" y="770040"/>
                <a:ext cx="2838960" cy="313560"/>
                <a:chOff x="977760" y="770040"/>
                <a:chExt cx="2838960" cy="313560"/>
              </a:xfrm>
            </p:grpSpPr>
            <p:sp>
              <p:nvSpPr>
                <p:cNvPr id="58" name=""/>
                <p:cNvSpPr/>
                <p:nvPr/>
              </p:nvSpPr>
              <p:spPr>
                <a:xfrm>
                  <a:off x="977760" y="844560"/>
                  <a:ext cx="263520" cy="169920"/>
                </a:xfrm>
                <a:prstGeom prst="rect">
                  <a:avLst/>
                </a:prstGeom>
                <a:solidFill>
                  <a:srgbClr val="b2b2b2"/>
                </a:solidFill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2057400" y="843120"/>
                  <a:ext cx="263520" cy="169920"/>
                </a:xfrm>
                <a:prstGeom prst="rect">
                  <a:avLst/>
                </a:prstGeom>
                <a:solidFill>
                  <a:srgbClr val="000000"/>
                </a:solidFill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3009960" y="844560"/>
                  <a:ext cx="263520" cy="169920"/>
                </a:xfrm>
                <a:prstGeom prst="rect">
                  <a:avLst/>
                </a:prstGeom>
                <a:solidFill>
                  <a:srgbClr val="ffffff"/>
                </a:solidFill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1209960" y="776520"/>
                  <a:ext cx="7783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100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µ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2296080" y="770040"/>
                  <a:ext cx="6793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10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µ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3236400" y="776520"/>
                  <a:ext cx="5803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1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µ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64" name=""/>
            <p:cNvSpPr/>
            <p:nvPr/>
          </p:nvSpPr>
          <p:spPr>
            <a:xfrm>
              <a:off x="2861280" y="1538640"/>
              <a:ext cx="35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"/>
          <p:cNvSpPr/>
          <p:nvPr/>
        </p:nvSpPr>
        <p:spPr>
          <a:xfrm>
            <a:off x="1585800" y="0"/>
            <a:ext cx="3861000" cy="54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Irigoyen et al. Additional Figure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31T10:16:13Z</dcterms:created>
  <dc:creator>Centro de Tecnología Informática</dc:creator>
  <dc:description/>
  <dc:language>en-US</dc:language>
  <cp:lastModifiedBy>Centro de Tecnología Informática</cp:lastModifiedBy>
  <dcterms:modified xsi:type="dcterms:W3CDTF">2010-05-19T10:46:47Z</dcterms:modified>
  <cp:revision>4</cp:revision>
  <dc:subject/>
  <dc:title>Diapositiva 1</dc:title>
</cp:coreProperties>
</file>